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82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6" d="100"/>
          <a:sy n="126" d="100"/>
        </p:scale>
        <p:origin x="117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33EF66-7922-4808-BA1D-5874071B3A00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6F2D2F-673F-4FD6-883C-ED3A8676834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3356711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86163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21701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2" y="365126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70700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67358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2"/>
            <a:ext cx="7886700" cy="2852737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7"/>
            <a:ext cx="7886700" cy="150018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84237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36029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9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2" y="1681164"/>
            <a:ext cx="3887391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83302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56968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1532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9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2" y="987429"/>
            <a:ext cx="4629151" cy="4873625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2" y="2057400"/>
            <a:ext cx="2949179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37789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9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2" y="987429"/>
            <a:ext cx="4629151" cy="4873625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2" y="2057400"/>
            <a:ext cx="2949179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12649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4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A8BD7-C358-4DF2-867A-BF66DCABCEB4}" type="datetimeFigureOut">
              <a:rPr lang="de-CH" smtClean="0"/>
              <a:t>03.04.20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4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4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4F97E-E947-49F2-A779-C957859ACD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5594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ieren 7">
            <a:extLst>
              <a:ext uri="{FF2B5EF4-FFF2-40B4-BE49-F238E27FC236}">
                <a16:creationId xmlns:a16="http://schemas.microsoft.com/office/drawing/2014/main" id="{728F5895-44C5-88D1-2165-A7D2901AE905}"/>
              </a:ext>
            </a:extLst>
          </p:cNvPr>
          <p:cNvGrpSpPr/>
          <p:nvPr/>
        </p:nvGrpSpPr>
        <p:grpSpPr>
          <a:xfrm>
            <a:off x="40439" y="482600"/>
            <a:ext cx="9103587" cy="5922535"/>
            <a:chOff x="40439" y="482600"/>
            <a:chExt cx="9103587" cy="5922535"/>
          </a:xfrm>
        </p:grpSpPr>
        <p:grpSp>
          <p:nvGrpSpPr>
            <p:cNvPr id="4" name="Gruppieren 3"/>
            <p:cNvGrpSpPr/>
            <p:nvPr/>
          </p:nvGrpSpPr>
          <p:grpSpPr>
            <a:xfrm>
              <a:off x="40439" y="482600"/>
              <a:ext cx="9103587" cy="5922535"/>
              <a:chOff x="1923318" y="650639"/>
              <a:chExt cx="9385827" cy="6003927"/>
            </a:xfrm>
          </p:grpSpPr>
          <p:pic>
            <p:nvPicPr>
              <p:cNvPr id="7" name="Grafik 6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775" r="68055" b="1288"/>
              <a:stretch/>
            </p:blipFill>
            <p:spPr>
              <a:xfrm>
                <a:off x="7981732" y="650639"/>
                <a:ext cx="3327413" cy="5837437"/>
              </a:xfrm>
              <a:prstGeom prst="rect">
                <a:avLst/>
              </a:prstGeom>
            </p:spPr>
          </p:pic>
          <p:pic>
            <p:nvPicPr>
              <p:cNvPr id="9" name="Grafik 8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0" t="27769" r="74653" b="1177"/>
              <a:stretch/>
            </p:blipFill>
            <p:spPr>
              <a:xfrm>
                <a:off x="1923318" y="652839"/>
                <a:ext cx="3298610" cy="5934009"/>
              </a:xfrm>
              <a:prstGeom prst="rect">
                <a:avLst/>
              </a:prstGeom>
            </p:spPr>
          </p:pic>
          <p:grpSp>
            <p:nvGrpSpPr>
              <p:cNvPr id="2" name="Gruppieren 1"/>
              <p:cNvGrpSpPr>
                <a:grpSpLocks noChangeAspect="1"/>
              </p:cNvGrpSpPr>
              <p:nvPr/>
            </p:nvGrpSpPr>
            <p:grpSpPr>
              <a:xfrm>
                <a:off x="4989118" y="938897"/>
                <a:ext cx="3210096" cy="5574519"/>
                <a:chOff x="4989118" y="938897"/>
                <a:chExt cx="3210096" cy="5574519"/>
              </a:xfrm>
            </p:grpSpPr>
            <p:grpSp>
              <p:nvGrpSpPr>
                <p:cNvPr id="28" name="Gruppieren 27"/>
                <p:cNvGrpSpPr>
                  <a:grpSpLocks noChangeAspect="1"/>
                </p:cNvGrpSpPr>
                <p:nvPr/>
              </p:nvGrpSpPr>
              <p:grpSpPr>
                <a:xfrm>
                  <a:off x="4989118" y="938897"/>
                  <a:ext cx="3144788" cy="5574519"/>
                  <a:chOff x="3519378" y="621598"/>
                  <a:chExt cx="3375782" cy="5983981"/>
                </a:xfrm>
              </p:grpSpPr>
              <p:pic>
                <p:nvPicPr>
                  <p:cNvPr id="14" name="Grafik 13"/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729" t="1676" r="56710"/>
                  <a:stretch/>
                </p:blipFill>
                <p:spPr>
                  <a:xfrm>
                    <a:off x="3519378" y="621598"/>
                    <a:ext cx="3375782" cy="5860163"/>
                  </a:xfrm>
                  <a:prstGeom prst="rect">
                    <a:avLst/>
                  </a:prstGeom>
                </p:spPr>
              </p:pic>
              <p:pic>
                <p:nvPicPr>
                  <p:cNvPr id="27" name="Grafik 26"/>
                  <p:cNvPicPr>
                    <a:picLocks noChangeAspect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95018" r="90521" b="587"/>
                  <a:stretch/>
                </p:blipFill>
                <p:spPr>
                  <a:xfrm>
                    <a:off x="5682599" y="6310304"/>
                    <a:ext cx="1010539" cy="295275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29" name="Rechteck 28"/>
                <p:cNvSpPr/>
                <p:nvPr/>
              </p:nvSpPr>
              <p:spPr>
                <a:xfrm>
                  <a:off x="8125887" y="938898"/>
                  <a:ext cx="73327" cy="54735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CH"/>
                </a:p>
              </p:txBody>
            </p:sp>
          </p:grpSp>
          <p:sp>
            <p:nvSpPr>
              <p:cNvPr id="10" name="Textfeld 9"/>
              <p:cNvSpPr txBox="1"/>
              <p:nvPr/>
            </p:nvSpPr>
            <p:spPr>
              <a:xfrm>
                <a:off x="2595192" y="4099060"/>
                <a:ext cx="1621749" cy="3120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/>
                  <a:t>Outer curvature</a:t>
                </a:r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>
                <a:off x="5927365" y="4129959"/>
                <a:ext cx="1541865" cy="3120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/>
                  <a:t>Outer curvature</a:t>
                </a:r>
              </a:p>
            </p:txBody>
          </p:sp>
          <p:sp>
            <p:nvSpPr>
              <p:cNvPr id="13" name="Textfeld 12"/>
              <p:cNvSpPr txBox="1"/>
              <p:nvPr/>
            </p:nvSpPr>
            <p:spPr>
              <a:xfrm>
                <a:off x="8995591" y="4219348"/>
                <a:ext cx="1621749" cy="3120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/>
                  <a:t>Outer curvature</a:t>
                </a:r>
              </a:p>
            </p:txBody>
          </p:sp>
          <p:sp>
            <p:nvSpPr>
              <p:cNvPr id="15" name="Textfeld 14"/>
              <p:cNvSpPr txBox="1"/>
              <p:nvPr/>
            </p:nvSpPr>
            <p:spPr>
              <a:xfrm>
                <a:off x="2647357" y="4519615"/>
                <a:ext cx="1621749" cy="3120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/>
                  <a:t>Inner curvature</a:t>
                </a:r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>
                <a:off x="5939695" y="4564483"/>
                <a:ext cx="1621749" cy="3120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/>
                  <a:t>Inner curvature</a:t>
                </a:r>
              </a:p>
            </p:txBody>
          </p:sp>
          <p:sp>
            <p:nvSpPr>
              <p:cNvPr id="17" name="Textfeld 16"/>
              <p:cNvSpPr txBox="1"/>
              <p:nvPr/>
            </p:nvSpPr>
            <p:spPr>
              <a:xfrm>
                <a:off x="9045204" y="4666896"/>
                <a:ext cx="1621749" cy="3120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400" dirty="0"/>
                  <a:t>Inner curvature</a:t>
                </a:r>
              </a:p>
            </p:txBody>
          </p:sp>
          <p:sp>
            <p:nvSpPr>
              <p:cNvPr id="3" name="Rechteck 2"/>
              <p:cNvSpPr/>
              <p:nvPr/>
            </p:nvSpPr>
            <p:spPr>
              <a:xfrm>
                <a:off x="1923318" y="6164424"/>
                <a:ext cx="761516" cy="43748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0" name="Rechteck 19"/>
              <p:cNvSpPr/>
              <p:nvPr/>
            </p:nvSpPr>
            <p:spPr>
              <a:xfrm>
                <a:off x="7069628" y="6217081"/>
                <a:ext cx="761516" cy="43748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1" name="Rechteck 20"/>
              <p:cNvSpPr/>
              <p:nvPr/>
            </p:nvSpPr>
            <p:spPr>
              <a:xfrm>
                <a:off x="8199215" y="6217080"/>
                <a:ext cx="761516" cy="43748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grpSp>
          <p:nvGrpSpPr>
            <p:cNvPr id="5" name="Gruppieren 4"/>
            <p:cNvGrpSpPr/>
            <p:nvPr/>
          </p:nvGrpSpPr>
          <p:grpSpPr>
            <a:xfrm>
              <a:off x="5952091" y="5587618"/>
              <a:ext cx="666000" cy="276999"/>
              <a:chOff x="7659374" y="5832085"/>
              <a:chExt cx="666000" cy="276999"/>
            </a:xfrm>
          </p:grpSpPr>
          <p:cxnSp>
            <p:nvCxnSpPr>
              <p:cNvPr id="18" name="Gerader Verbinder 17"/>
              <p:cNvCxnSpPr/>
              <p:nvPr/>
            </p:nvCxnSpPr>
            <p:spPr>
              <a:xfrm>
                <a:off x="7659374" y="6092431"/>
                <a:ext cx="666000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feld 18"/>
              <p:cNvSpPr txBox="1"/>
              <p:nvPr/>
            </p:nvSpPr>
            <p:spPr>
              <a:xfrm>
                <a:off x="7693242" y="5832085"/>
                <a:ext cx="5907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b="1" dirty="0"/>
                  <a:t>5 mm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61146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äsentation1" id="{0D07E224-1AEA-4D14-9DDE-C1255DBC2088}" vid="{9F4E5442-D9BF-4C96-9FCE-39473591A0B4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14</Words>
  <Application>Microsoft Office PowerPoint</Application>
  <PresentationFormat>Bildschirmpräsentatio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</vt:lpstr>
      <vt:lpstr>PowerPoint-Präsentation</vt:lpstr>
    </vt:vector>
  </TitlesOfParts>
  <Company>Universitätsspital 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lder für Histopaper</dc:title>
  <dc:creator>Yundung Yankey</dc:creator>
  <cp:lastModifiedBy>Pelisek Jaroslav</cp:lastModifiedBy>
  <cp:revision>262</cp:revision>
  <cp:lastPrinted>2024-09-17T08:27:24Z</cp:lastPrinted>
  <dcterms:created xsi:type="dcterms:W3CDTF">2024-05-31T07:58:31Z</dcterms:created>
  <dcterms:modified xsi:type="dcterms:W3CDTF">2025-04-03T07:57:04Z</dcterms:modified>
</cp:coreProperties>
</file>